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125" d="100"/>
          <a:sy n="125" d="100"/>
        </p:scale>
        <p:origin x="-129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226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222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810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452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005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374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797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193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2135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212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607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365DE4-9A8C-41A7-97CA-564BA4413E6A}" type="datetimeFigureOut">
              <a:rPr lang="en-US" smtClean="0"/>
              <a:t>5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654E20-9DA5-4273-ACD7-700DBC4051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407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5416" y="2446338"/>
            <a:ext cx="764949" cy="7910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5232" y="2316056"/>
            <a:ext cx="2780210" cy="45576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160643" y="6042332"/>
            <a:ext cx="800219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/>
              <a:t>N=336</a:t>
            </a:r>
            <a:endParaRPr lang="en-US" dirty="0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65" y="3352800"/>
            <a:ext cx="2514600" cy="32473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17037" y="6048701"/>
            <a:ext cx="800219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/>
              <a:t>N=227</a:t>
            </a:r>
            <a:endParaRPr lang="en-US" dirty="0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76071" y="2841884"/>
            <a:ext cx="2262946" cy="3784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9" name="Straight Connector 8"/>
          <p:cNvCxnSpPr/>
          <p:nvPr/>
        </p:nvCxnSpPr>
        <p:spPr>
          <a:xfrm>
            <a:off x="1587748" y="5891262"/>
            <a:ext cx="656565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248400" y="6042332"/>
            <a:ext cx="800219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/>
              <a:t>N=237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270565" y="1778898"/>
            <a:ext cx="968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seline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466981" y="1778898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 hour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6504513" y="1837982"/>
            <a:ext cx="1003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4 hours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 rot="16200000">
            <a:off x="1311443" y="6132305"/>
            <a:ext cx="886781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/>
              <a:t>GENBOREE</a:t>
            </a:r>
          </a:p>
          <a:p>
            <a:pPr algn="r"/>
            <a:r>
              <a:rPr lang="en-US" sz="1200" b="1" dirty="0" smtClean="0"/>
              <a:t>Mayo</a:t>
            </a:r>
            <a:endParaRPr lang="en-US" sz="120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4299144" y="6182105"/>
            <a:ext cx="886781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/>
              <a:t>GENBOREE</a:t>
            </a:r>
          </a:p>
          <a:p>
            <a:pPr algn="r"/>
            <a:r>
              <a:rPr lang="en-US" sz="1200" b="1" dirty="0" smtClean="0"/>
              <a:t>Mayo</a:t>
            </a:r>
            <a:endParaRPr lang="en-US" sz="1200" b="1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7492255" y="6118496"/>
            <a:ext cx="886781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/>
              <a:t>GENBOREE</a:t>
            </a:r>
          </a:p>
          <a:p>
            <a:pPr algn="r"/>
            <a:r>
              <a:rPr lang="en-US" sz="1200" b="1" dirty="0" smtClean="0"/>
              <a:t>Mayo</a:t>
            </a:r>
            <a:endParaRPr lang="en-US" sz="1200" b="1" dirty="0"/>
          </a:p>
        </p:txBody>
      </p:sp>
      <p:sp>
        <p:nvSpPr>
          <p:cNvPr id="17" name="Rectangle 16"/>
          <p:cNvSpPr/>
          <p:nvPr/>
        </p:nvSpPr>
        <p:spPr>
          <a:xfrm>
            <a:off x="609599" y="457200"/>
            <a:ext cx="802941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dirty="0" smtClean="0">
                <a:solidFill>
                  <a:prstClr val="black"/>
                </a:solidFill>
              </a:rPr>
              <a:t>S2 Figure: </a:t>
            </a:r>
            <a:r>
              <a:rPr lang="en-US" dirty="0">
                <a:solidFill>
                  <a:prstClr val="black"/>
                </a:solidFill>
              </a:rPr>
              <a:t>Heat-map of </a:t>
            </a:r>
            <a:r>
              <a:rPr lang="en-US" dirty="0" smtClean="0">
                <a:solidFill>
                  <a:prstClr val="black"/>
                </a:solidFill>
              </a:rPr>
              <a:t>miRNA expression. Normalized Reads </a:t>
            </a:r>
            <a:r>
              <a:rPr lang="en-US" dirty="0">
                <a:solidFill>
                  <a:prstClr val="black"/>
                </a:solidFill>
              </a:rPr>
              <a:t>Count:  </a:t>
            </a:r>
          </a:p>
          <a:p>
            <a:pPr lvl="0"/>
            <a:r>
              <a:rPr lang="en-US" dirty="0">
                <a:solidFill>
                  <a:prstClr val="black"/>
                </a:solidFill>
              </a:rPr>
              <a:t>log2(1 + </a:t>
            </a:r>
            <a:r>
              <a:rPr lang="en-US" dirty="0" err="1">
                <a:solidFill>
                  <a:prstClr val="black"/>
                </a:solidFill>
              </a:rPr>
              <a:t>raw_read_count</a:t>
            </a:r>
            <a:r>
              <a:rPr lang="en-US" dirty="0">
                <a:solidFill>
                  <a:prstClr val="black"/>
                </a:solidFill>
              </a:rPr>
              <a:t> * 100000/(</a:t>
            </a:r>
            <a:r>
              <a:rPr lang="en-US" dirty="0" err="1">
                <a:solidFill>
                  <a:prstClr val="black"/>
                </a:solidFill>
              </a:rPr>
              <a:t>reads_mapped_to_mature_miRBase</a:t>
            </a:r>
            <a:r>
              <a:rPr lang="en-US" dirty="0">
                <a:solidFill>
                  <a:prstClr val="black"/>
                </a:solidFill>
              </a:rPr>
              <a:t>) )</a:t>
            </a:r>
          </a:p>
          <a:p>
            <a:pPr lvl="0"/>
            <a:endParaRPr 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5601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ushar Patel</dc:creator>
  <cp:lastModifiedBy>Tushar Patel</cp:lastModifiedBy>
  <cp:revision>1</cp:revision>
  <dcterms:created xsi:type="dcterms:W3CDTF">2016-05-09T23:53:54Z</dcterms:created>
  <dcterms:modified xsi:type="dcterms:W3CDTF">2016-05-09T23:54:12Z</dcterms:modified>
</cp:coreProperties>
</file>